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FI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5884"/>
  </p:normalViewPr>
  <p:slideViewPr>
    <p:cSldViewPr snapToGrid="0">
      <p:cViewPr>
        <p:scale>
          <a:sx n="86" d="100"/>
          <a:sy n="86" d="100"/>
        </p:scale>
        <p:origin x="296" y="5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8553B3-67AC-4FF1-3CD2-77B77E664B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FI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FD949EB-967F-0470-ACAE-6C8AE2EB63E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C4C1EE-4674-F426-9F65-9300CA06B9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3B961-5D53-5A4B-93E9-5B0AD6D7B250}" type="datetimeFigureOut">
              <a:rPr lang="en-FI" smtClean="0"/>
              <a:t>30.8.2022</a:t>
            </a:fld>
            <a:endParaRPr lang="en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D03646-91CC-E428-A245-A7CFC8E200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B47870-EBCD-F67B-FAE0-B79BABF360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36615-D07C-D549-8AC5-1DDFC4D94427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2299136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06DD32-4005-F86A-028E-3E74FCC406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FI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1889F2-05CE-719E-EB9D-23655705B8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420A36-064E-0247-D68E-D65200144D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3B961-5D53-5A4B-93E9-5B0AD6D7B250}" type="datetimeFigureOut">
              <a:rPr lang="en-FI" smtClean="0"/>
              <a:t>30.8.2022</a:t>
            </a:fld>
            <a:endParaRPr lang="en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82044C-7AAB-261A-1001-B985EDF314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93C55F-8E8A-7F40-46E0-3E0E2398F7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36615-D07C-D549-8AC5-1DDFC4D94427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26227820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1D1297B-F008-D4E4-6CB6-B56C4A0F20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FI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9760200-4D9C-EE8A-B086-38F66F7F10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D65777-3A5B-0C66-452E-4240102DBD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3B961-5D53-5A4B-93E9-5B0AD6D7B250}" type="datetimeFigureOut">
              <a:rPr lang="en-FI" smtClean="0"/>
              <a:t>30.8.2022</a:t>
            </a:fld>
            <a:endParaRPr lang="en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81F6EA-760F-4010-4C35-8A52806D4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FDB1B1-D895-A16E-39A7-F64F010C45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36615-D07C-D549-8AC5-1DDFC4D94427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37647313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E8393F-6136-EAAF-CB23-1CA5411BB4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DD8751-EDEC-396A-6107-500058A0734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4F662E-0936-7516-6223-5D442B758D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3B961-5D53-5A4B-93E9-5B0AD6D7B250}" type="datetimeFigureOut">
              <a:rPr lang="en-FI" smtClean="0"/>
              <a:t>30.8.2022</a:t>
            </a:fld>
            <a:endParaRPr lang="en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3EBD92-9FF0-B14E-3748-78850B402B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84982B-CCEB-CCB3-2FF4-3E7599C23A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36615-D07C-D549-8AC5-1DDFC4D94427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7722412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4DC69C-E994-1BDB-AD98-B8B8470282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F493E5-4FBA-AEB1-7F8C-4116BE1479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1AD5CF-4084-0F97-D221-93C77E1B17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3B961-5D53-5A4B-93E9-5B0AD6D7B250}" type="datetimeFigureOut">
              <a:rPr lang="en-FI" smtClean="0"/>
              <a:t>30.8.2022</a:t>
            </a:fld>
            <a:endParaRPr lang="en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BD4088-2585-0A17-ABC9-3A04ED192D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9BBA78-FE52-22C5-ACC0-3C67FC235E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36615-D07C-D549-8AC5-1DDFC4D94427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25186949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30C621-3C07-8B91-2405-5FBFB6927B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954083-D627-4C64-A672-5F4EF4B0FE8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I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2A8392A-AEAF-5F43-2B2D-51761A537F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I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3E45D2F-4696-FAF0-7D55-FD9F18A6DC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3B961-5D53-5A4B-93E9-5B0AD6D7B250}" type="datetimeFigureOut">
              <a:rPr lang="en-FI" smtClean="0"/>
              <a:t>30.8.2022</a:t>
            </a:fld>
            <a:endParaRPr lang="en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47335C-3CD6-23AD-07AF-328CCF52E1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EB0622-8579-890F-F307-CCE81007C6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36615-D07C-D549-8AC5-1DDFC4D94427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3509405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8DA3B1-8F3A-3CC1-A003-AE3D1DA514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598A9D-B39B-6C70-E351-4C7720E8AF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B52A4C3-83BC-CDAF-E965-ED226A2D53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I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DD352C6-7476-9D97-6B5F-C6A3518268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ECB9284-2A2E-3FEA-62AA-2DECA1BF0C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I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149630D-7964-17FF-CB57-7DF2E0262D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3B961-5D53-5A4B-93E9-5B0AD6D7B250}" type="datetimeFigureOut">
              <a:rPr lang="en-FI" smtClean="0"/>
              <a:t>30.8.2022</a:t>
            </a:fld>
            <a:endParaRPr lang="en-FI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4AF1599-C112-5611-F357-6F05511DFE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33A1F47-B1A0-FA23-FDBA-7FEA9D98DE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36615-D07C-D549-8AC5-1DDFC4D94427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40785230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00E184-8D35-1E58-3BFB-44EDB74AC7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FI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0FA17BF-9EC1-DA2E-A474-4ED19598B3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3B961-5D53-5A4B-93E9-5B0AD6D7B250}" type="datetimeFigureOut">
              <a:rPr lang="en-FI" smtClean="0"/>
              <a:t>30.8.2022</a:t>
            </a:fld>
            <a:endParaRPr lang="en-FI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4F48B8A-3030-BB01-E2F1-7E848FEF48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35DE4C3-71A6-E40E-335E-34E4EA2F7E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36615-D07C-D549-8AC5-1DDFC4D94427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16693461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5DE4945-9EC1-4EAA-7D31-D2C4FD140F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3B961-5D53-5A4B-93E9-5B0AD6D7B250}" type="datetimeFigureOut">
              <a:rPr lang="en-FI" smtClean="0"/>
              <a:t>30.8.2022</a:t>
            </a:fld>
            <a:endParaRPr lang="en-FI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F025DAA-D89B-E803-0E64-21ADC40FAE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8609C2B-B0E8-DC53-19EA-E355FDD637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36615-D07C-D549-8AC5-1DDFC4D94427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31730193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F59D72-DBAF-8682-F19F-366B3E068B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1C7E6C-E840-DCC8-EE97-096EE36613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I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9551120-0174-AE4F-3645-6BCF0BFE6A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6E7748-4345-3CC8-E7DE-F39741F05D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3B961-5D53-5A4B-93E9-5B0AD6D7B250}" type="datetimeFigureOut">
              <a:rPr lang="en-FI" smtClean="0"/>
              <a:t>30.8.2022</a:t>
            </a:fld>
            <a:endParaRPr lang="en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89AD94-5C4F-4B2E-5913-56F717E36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4DB215-7372-CEBD-CF4B-7D435A15FC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36615-D07C-D549-8AC5-1DDFC4D94427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936622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D3DEC3-4A6E-3723-F174-4D5B7C142D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FI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4239358-060C-F89A-6A7A-2C19D61163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FI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AA25FD0-52E4-E14F-1385-2127EA933F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F78ABC-443C-F4EA-8EC7-83B5E83D3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3B961-5D53-5A4B-93E9-5B0AD6D7B250}" type="datetimeFigureOut">
              <a:rPr lang="en-FI" smtClean="0"/>
              <a:t>30.8.2022</a:t>
            </a:fld>
            <a:endParaRPr lang="en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0CE258-A0D0-6DCC-4F5C-F1609FBFCA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B3C64B-D273-F069-3F62-1ADF9BBF6F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36615-D07C-D549-8AC5-1DDFC4D94427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26024285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8EA242B-7EE0-0143-080F-133A3F68FA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F2B722-F2B9-D457-0645-D1E0E5DDF2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70B2E9-BC14-C81A-5BDD-2E8B59CA18A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3B961-5D53-5A4B-93E9-5B0AD6D7B250}" type="datetimeFigureOut">
              <a:rPr lang="en-FI" smtClean="0"/>
              <a:t>30.8.2022</a:t>
            </a:fld>
            <a:endParaRPr lang="en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F9D161-FA88-9B6A-3986-85E7459479F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1F1767-084F-255A-EF27-B708092C31E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E36615-D07C-D549-8AC5-1DDFC4D94427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36481409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FB32540D-5AA8-57CE-2093-BEBC0C3FA8B5}"/>
              </a:ext>
            </a:extLst>
          </p:cNvPr>
          <p:cNvGrpSpPr/>
          <p:nvPr/>
        </p:nvGrpSpPr>
        <p:grpSpPr>
          <a:xfrm>
            <a:off x="2178639" y="-152737"/>
            <a:ext cx="12270259" cy="8180173"/>
            <a:chOff x="448963" y="457200"/>
            <a:chExt cx="10565026" cy="640080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B1DB1F8B-74D5-1020-04AF-6C9DB4EEBAA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48963" y="457200"/>
              <a:ext cx="6400800" cy="64008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E91858AE-18E9-5953-028A-E5E2FEA2B87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613189" y="457200"/>
              <a:ext cx="6400800" cy="640080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7219F7D-7E8E-CE47-065E-54CA4F205480}"/>
                </a:ext>
              </a:extLst>
            </p:cNvPr>
            <p:cNvSpPr txBox="1"/>
            <p:nvPr/>
          </p:nvSpPr>
          <p:spPr>
            <a:xfrm>
              <a:off x="1091512" y="766119"/>
              <a:ext cx="36260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FI" sz="2400" dirty="0"/>
                <a:t>A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57D8F24-0C83-F4E0-7813-A113B2806BC8}"/>
                </a:ext>
              </a:extLst>
            </p:cNvPr>
            <p:cNvSpPr txBox="1"/>
            <p:nvPr/>
          </p:nvSpPr>
          <p:spPr>
            <a:xfrm>
              <a:off x="5247510" y="757878"/>
              <a:ext cx="36260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FI" sz="2400" dirty="0"/>
                <a:t>B</a:t>
              </a: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7E400E6E-2686-C2A6-6E49-E40E86DE7D0F}"/>
              </a:ext>
            </a:extLst>
          </p:cNvPr>
          <p:cNvSpPr txBox="1"/>
          <p:nvPr/>
        </p:nvSpPr>
        <p:spPr>
          <a:xfrm>
            <a:off x="0" y="1001577"/>
            <a:ext cx="2618730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FI" dirty="0"/>
              <a:t>Supplementary Figure 1</a:t>
            </a:r>
          </a:p>
          <a:p>
            <a:r>
              <a:rPr lang="fi-FI" dirty="0" err="1"/>
              <a:t>Relative</a:t>
            </a:r>
            <a:r>
              <a:rPr lang="fi-FI" dirty="0"/>
              <a:t> </a:t>
            </a:r>
            <a:r>
              <a:rPr lang="fi-FI" dirty="0" err="1"/>
              <a:t>abundance</a:t>
            </a:r>
            <a:r>
              <a:rPr lang="fi-FI" dirty="0"/>
              <a:t> of </a:t>
            </a:r>
          </a:p>
          <a:p>
            <a:r>
              <a:rPr lang="fi-FI" dirty="0" err="1"/>
              <a:t>the</a:t>
            </a:r>
            <a:r>
              <a:rPr lang="fi-FI" dirty="0"/>
              <a:t> </a:t>
            </a:r>
            <a:r>
              <a:rPr lang="fi-FI" dirty="0" err="1"/>
              <a:t>most</a:t>
            </a:r>
            <a:r>
              <a:rPr lang="fi-FI" dirty="0"/>
              <a:t> </a:t>
            </a:r>
            <a:r>
              <a:rPr lang="fi-FI" dirty="0" err="1"/>
              <a:t>abundant</a:t>
            </a:r>
            <a:endParaRPr lang="fi-FI" dirty="0"/>
          </a:p>
          <a:p>
            <a:r>
              <a:rPr lang="fi-FI" dirty="0" err="1"/>
              <a:t>bacteria</a:t>
            </a:r>
            <a:r>
              <a:rPr lang="fi-FI" dirty="0"/>
              <a:t> (A) and </a:t>
            </a:r>
            <a:r>
              <a:rPr lang="fi-FI" dirty="0" err="1"/>
              <a:t>Fungi</a:t>
            </a:r>
            <a:r>
              <a:rPr lang="fi-FI" dirty="0"/>
              <a:t> (B) </a:t>
            </a:r>
          </a:p>
          <a:p>
            <a:r>
              <a:rPr lang="fi-FI" dirty="0" err="1"/>
              <a:t>by</a:t>
            </a:r>
            <a:r>
              <a:rPr lang="fi-FI" dirty="0"/>
              <a:t> </a:t>
            </a:r>
            <a:r>
              <a:rPr lang="fi-FI" dirty="0" err="1"/>
              <a:t>season</a:t>
            </a:r>
            <a:endParaRPr lang="en-FI" dirty="0"/>
          </a:p>
        </p:txBody>
      </p:sp>
    </p:spTree>
    <p:extLst>
      <p:ext uri="{BB962C8B-B14F-4D97-AF65-F5344CB8AC3E}">
        <p14:creationId xmlns:p14="http://schemas.microsoft.com/office/powerpoint/2010/main" val="35942022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AFC2473C-4C13-EDE4-7E2B-0C1D7E9201A1}"/>
              </a:ext>
            </a:extLst>
          </p:cNvPr>
          <p:cNvGrpSpPr/>
          <p:nvPr/>
        </p:nvGrpSpPr>
        <p:grpSpPr>
          <a:xfrm>
            <a:off x="3452021" y="-39600"/>
            <a:ext cx="8736788" cy="6883417"/>
            <a:chOff x="2432690" y="-39600"/>
            <a:chExt cx="8736788" cy="6883417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737E3168-C2FB-2DAD-4959-40F4000C3613}"/>
                </a:ext>
              </a:extLst>
            </p:cNvPr>
            <p:cNvGrpSpPr/>
            <p:nvPr/>
          </p:nvGrpSpPr>
          <p:grpSpPr>
            <a:xfrm>
              <a:off x="2496406" y="3087"/>
              <a:ext cx="8673072" cy="6840730"/>
              <a:chOff x="2534506" y="-111213"/>
              <a:chExt cx="8673072" cy="6840730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8BD7C2CC-CF52-67E0-2E97-7205474962A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2318"/>
              <a:stretch/>
            </p:blipFill>
            <p:spPr>
              <a:xfrm>
                <a:off x="2806700" y="-111212"/>
                <a:ext cx="8400878" cy="6840729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2D2739C0-FA3A-F552-0E67-D8B8EC8672B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49229" r="47606"/>
              <a:stretch/>
            </p:blipFill>
            <p:spPr>
              <a:xfrm>
                <a:off x="2534506" y="-111213"/>
                <a:ext cx="272193" cy="6840729"/>
              </a:xfrm>
              <a:prstGeom prst="rect">
                <a:avLst/>
              </a:prstGeom>
            </p:spPr>
          </p:pic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50D8CB6-E4D8-14CF-72BC-640B3188637A}"/>
                </a:ext>
              </a:extLst>
            </p:cNvPr>
            <p:cNvSpPr txBox="1"/>
            <p:nvPr/>
          </p:nvSpPr>
          <p:spPr>
            <a:xfrm>
              <a:off x="2432690" y="-38100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FI" dirty="0"/>
                <a:t>A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AC7685C-D9B0-CA28-1207-731A869F8DE8}"/>
                </a:ext>
              </a:extLst>
            </p:cNvPr>
            <p:cNvSpPr txBox="1"/>
            <p:nvPr/>
          </p:nvSpPr>
          <p:spPr>
            <a:xfrm>
              <a:off x="6725290" y="-39600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FI" dirty="0"/>
                <a:t>B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2E8F0B8-C12F-0C54-D730-0D18B2F529C1}"/>
                </a:ext>
              </a:extLst>
            </p:cNvPr>
            <p:cNvSpPr txBox="1"/>
            <p:nvPr/>
          </p:nvSpPr>
          <p:spPr>
            <a:xfrm>
              <a:off x="2432690" y="2222500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FI" dirty="0"/>
                <a:t>C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722BE8C-0713-4465-A84F-A9BB9E43FBC4}"/>
                </a:ext>
              </a:extLst>
            </p:cNvPr>
            <p:cNvSpPr txBox="1"/>
            <p:nvPr/>
          </p:nvSpPr>
          <p:spPr>
            <a:xfrm>
              <a:off x="6725290" y="2221000"/>
              <a:ext cx="3273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FI" dirty="0"/>
                <a:t>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3368A75-AF25-3375-B085-58E9E15E99A2}"/>
                </a:ext>
              </a:extLst>
            </p:cNvPr>
            <p:cNvSpPr txBox="1"/>
            <p:nvPr/>
          </p:nvSpPr>
          <p:spPr>
            <a:xfrm>
              <a:off x="2432690" y="4559300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FI" dirty="0"/>
                <a:t>E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9224D9F-46C8-84DC-F6D6-BA5F495462B0}"/>
                </a:ext>
              </a:extLst>
            </p:cNvPr>
            <p:cNvSpPr txBox="1"/>
            <p:nvPr/>
          </p:nvSpPr>
          <p:spPr>
            <a:xfrm>
              <a:off x="6725290" y="4557800"/>
              <a:ext cx="2904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FI" dirty="0"/>
                <a:t>F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C6BF9736-0BB5-B685-DC1C-06DC8DD7F226}"/>
              </a:ext>
            </a:extLst>
          </p:cNvPr>
          <p:cNvSpPr txBox="1"/>
          <p:nvPr/>
        </p:nvSpPr>
        <p:spPr>
          <a:xfrm>
            <a:off x="0" y="1001577"/>
            <a:ext cx="3552576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FI" dirty="0"/>
              <a:t>Supplementary Figure 2</a:t>
            </a:r>
          </a:p>
          <a:p>
            <a:r>
              <a:rPr lang="en-FI" dirty="0"/>
              <a:t>B</a:t>
            </a:r>
            <a:r>
              <a:rPr lang="en-GB" dirty="0"/>
              <a:t>a</a:t>
            </a:r>
            <a:r>
              <a:rPr lang="en-FI" dirty="0"/>
              <a:t>cterial a</a:t>
            </a:r>
            <a:r>
              <a:rPr lang="en-GB" dirty="0" err="1"/>
              <a:t>nd</a:t>
            </a:r>
            <a:r>
              <a:rPr lang="en-FI" dirty="0"/>
              <a:t> fungal aplha diversity</a:t>
            </a:r>
          </a:p>
          <a:p>
            <a:r>
              <a:rPr lang="en-GB" dirty="0"/>
              <a:t>g</a:t>
            </a:r>
            <a:r>
              <a:rPr lang="en-FI" dirty="0"/>
              <a:t>rouped by type of pat (A&amp;B), type</a:t>
            </a:r>
          </a:p>
          <a:p>
            <a:r>
              <a:rPr lang="en-GB" dirty="0"/>
              <a:t>O</a:t>
            </a:r>
            <a:r>
              <a:rPr lang="en-FI" dirty="0"/>
              <a:t>f housing (C&amp;D), and season (E&amp;F)</a:t>
            </a:r>
          </a:p>
        </p:txBody>
      </p:sp>
    </p:spTree>
    <p:extLst>
      <p:ext uri="{BB962C8B-B14F-4D97-AF65-F5344CB8AC3E}">
        <p14:creationId xmlns:p14="http://schemas.microsoft.com/office/powerpoint/2010/main" val="42463728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33</TotalTime>
  <Words>66</Words>
  <Application>Microsoft Macintosh PowerPoint</Application>
  <PresentationFormat>Widescreen</PresentationFormat>
  <Paragraphs>1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ri Korpela</dc:creator>
  <cp:lastModifiedBy>Katri Korpela</cp:lastModifiedBy>
  <cp:revision>3</cp:revision>
  <dcterms:created xsi:type="dcterms:W3CDTF">2022-08-25T11:40:57Z</dcterms:created>
  <dcterms:modified xsi:type="dcterms:W3CDTF">2022-08-31T11:46:20Z</dcterms:modified>
</cp:coreProperties>
</file>